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115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467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356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362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082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77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7111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5641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80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844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623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686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9C377-2CDD-C54B-B55C-A1305A73934E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1E2227-A496-E44A-8851-535711FF5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50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50UG-50_98UGa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687" y="252165"/>
            <a:ext cx="1716582" cy="173005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42178" y="315090"/>
            <a:ext cx="1382382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98_UG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7880" y="1194203"/>
            <a:ext cx="1550136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UG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5" name="Picture 4" descr="70UG-70_98UGa.tif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1563" y="333373"/>
            <a:ext cx="1567638" cy="156763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273463" y="1291471"/>
            <a:ext cx="1222508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UG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467883" y="315090"/>
            <a:ext cx="1324786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98_UG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0" name="Picture 9" descr="50HC-50_98HCa.tif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448" y="2553912"/>
            <a:ext cx="1598758" cy="159875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-60281" y="2749401"/>
            <a:ext cx="1296296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98_H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55936" y="3415717"/>
            <a:ext cx="1296296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HC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3" name="Picture 12" descr="70HC-70_98HCa.tif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04886" y="2536099"/>
            <a:ext cx="1509579" cy="1509579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7374606" y="3360223"/>
            <a:ext cx="1191875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HC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19" name="Picture 18" descr="50_98UG-70_98UGa.tif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3209" y="137481"/>
            <a:ext cx="2008732" cy="2008732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914792" y="315090"/>
            <a:ext cx="1617653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98_UG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804648" y="1361127"/>
            <a:ext cx="1617653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98_UG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27" name="Picture 26" descr="70_98UG-70_98_HCa.tif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8133" y="2515990"/>
            <a:ext cx="1701549" cy="170155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4141618" y="2749401"/>
            <a:ext cx="1260792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98_UG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302298" y="3531469"/>
            <a:ext cx="1260792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98_HC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31" name="Picture 30" descr="50_98UG-50_98_HCa.tif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3389" y="126662"/>
            <a:ext cx="1865335" cy="1865335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5254835" y="1243460"/>
            <a:ext cx="1340698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98_HC</a:t>
            </a:r>
            <a:endParaRPr lang="en-US" sz="1200" dirty="0">
              <a:latin typeface="Times New Roman"/>
              <a:cs typeface="Times New Roman"/>
            </a:endParaRPr>
          </a:p>
        </p:txBody>
      </p:sp>
      <p:pic>
        <p:nvPicPr>
          <p:cNvPr id="34" name="Picture 33" descr="50_98HC-70_98HCa.tiff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5812" y="2442971"/>
            <a:ext cx="1931602" cy="1931602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1611045" y="2749401"/>
            <a:ext cx="1550136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98_H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887147" y="3571504"/>
            <a:ext cx="1550136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98_H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061869" y="315090"/>
            <a:ext cx="1382382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50_98_UG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45247" y="2749401"/>
            <a:ext cx="1343971" cy="314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Times New Roman"/>
                <a:cs typeface="Times New Roman"/>
              </a:rPr>
              <a:t>Ref70_98_H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42178" y="4991878"/>
            <a:ext cx="87965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</a:t>
            </a:r>
            <a:r>
              <a:rPr lang="en-US" sz="1200" dirty="0" smtClean="0"/>
              <a:t>S2: </a:t>
            </a:r>
            <a:r>
              <a:rPr lang="en-US" sz="1200" dirty="0" smtClean="0"/>
              <a:t>Comparison of the  number of SNPs identified using different SNP callers (UG=Unified </a:t>
            </a:r>
            <a:r>
              <a:rPr lang="en-US" sz="1200" dirty="0" err="1" smtClean="0"/>
              <a:t>Genotyper</a:t>
            </a:r>
            <a:r>
              <a:rPr lang="en-US" sz="1200" dirty="0" smtClean="0"/>
              <a:t>; HC=Haplotype Caller) and different GBS references (Ref50: tags present in ≥50% of the samples; Ref70: tags present in ≥70% of the samples; Ref50_98: tags present in ≥50% of the samples and only 1 tag retained for tags with ≥98% homology; Ref70_98: tags present in ≥70</a:t>
            </a:r>
            <a:r>
              <a:rPr lang="en-US" sz="1200" dirty="0"/>
              <a:t>% of the samples and only 1 tag retained </a:t>
            </a:r>
            <a:r>
              <a:rPr lang="en-US" sz="1200" dirty="0" smtClean="0"/>
              <a:t>for </a:t>
            </a:r>
            <a:r>
              <a:rPr lang="en-US" sz="1200" dirty="0"/>
              <a:t>tags with </a:t>
            </a:r>
            <a:r>
              <a:rPr lang="en-US" sz="1200" dirty="0" smtClean="0"/>
              <a:t>≥98</a:t>
            </a:r>
            <a:r>
              <a:rPr lang="en-US" sz="1200" dirty="0"/>
              <a:t>% </a:t>
            </a:r>
            <a:r>
              <a:rPr lang="en-US" sz="1200" dirty="0" smtClean="0"/>
              <a:t>homology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28508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8</TotalTime>
  <Words>114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University of South Caroli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Pendergast</dc:creator>
  <cp:lastModifiedBy>Katrien M. Devos</cp:lastModifiedBy>
  <cp:revision>16</cp:revision>
  <dcterms:created xsi:type="dcterms:W3CDTF">2016-12-13T14:20:59Z</dcterms:created>
  <dcterms:modified xsi:type="dcterms:W3CDTF">2018-03-23T04:50:24Z</dcterms:modified>
</cp:coreProperties>
</file>